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2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02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FA1A9D-CC10-4D64-938F-D0C6C1B0EF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6AC8EF2-C3C5-4936-9D94-5CABF7D1F2E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07BDB-735E-4F3D-A4E0-0BEA784EA6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C98303-68D2-45FE-8FD6-D4E42AB60D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3FA97F2-795E-4AA0-A33C-A08C674C7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63029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0ABA84-5C80-4567-A60B-BD677C305C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23CD6F-BD26-4AC0-8D3B-5EE87607EA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9838C6-B629-4B90-9A30-C4922D2A3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F98FA9-1450-4EAC-AC1D-4851231A7B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D9329F-2706-4E40-99D5-F3945D5CC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648060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6770616-612F-4EDA-8CD1-FCFA8BA3B9C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8F7E44-31B6-4056-B9E5-00110011B1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1544BC-4985-40B3-82F5-C3AB3E920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2BC931-853F-45D5-9509-5BCE6124D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882BCE-C953-4E53-A770-D7E41BEB36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30319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BD3504-BAB2-4B89-B9BB-98F68E2E7E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58AD1E-38D1-4A2F-A7B5-F0814C051C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9100FC-5A57-4717-BCA6-DA7EE4FF10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840C85-01C7-4C8E-9B08-E134187914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8C010F-E4AD-4151-B6DF-E84609175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482403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28646F-63EE-4E57-8569-9E37FF1F14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C61DB3-0A6C-43DB-9C44-7BDC118D33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CF04AF-4740-4CE3-8C36-F78C6F3C21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610F28-270D-4B23-A65F-9D88D18166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FEAA89-4D28-4541-913E-C2D6C551A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222735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7AD70C-BBCE-4E5A-A89C-E71C02BEAD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1D9293-8ADF-4A33-91B0-7042331FEF9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DCF445-5DF0-43C0-93A2-F4B4447867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6F59BF-F5E9-4410-AD93-F2106991C4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07FEAB-AC11-42B8-A31A-B138161D4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5755B8-FDAD-4DF2-9295-1B914BC334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78993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77344E-89C4-41C8-9FB9-FC3A1A1DC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2C7A91-8728-4790-95E4-B25AC65573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656B86F-3ECD-4A48-8E32-E624735C0D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F09417A-637C-4CD7-A5AA-34081966A31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1EA4B23-B41C-4E33-A76A-2E907B9269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F5202C-0D90-4F00-A93F-723C0480F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6020B5-8D47-477A-A914-4E498C613E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F1904DC-9100-4789-8F53-2D2F88C92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17417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3BE4C1-DBCA-4F2F-AF62-E5871CB0F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01B3E31-1406-44F6-A3DB-457C05EEAB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4F0D355-2A03-434A-9D16-146E4AF393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A45AF7-14FD-4D24-A20F-6A8434EA9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696705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412C1E4-E915-4573-8648-9839D48547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5B50F8A-1191-48A8-8F85-A07A90F69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A5E1BE8-B97B-498D-B61A-51DC5029C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89786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6FF4C-D963-4E4F-B611-BE0FECF87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C03A1A-C3F7-4E4B-8DDD-539F6CA7DA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DA66CA-491B-4E73-9D25-B4A38A401D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EBF967-AC8A-4474-9746-8C693978B9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6E3643-3A50-4B18-BB56-E4A10E2D2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746D4B-DB2B-4565-8422-CD847322A8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46828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C67AF3-E533-41B7-BDC1-614C5E8D22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1577F67-3B4C-4779-A470-F46D115928B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7CABEB-0B9B-406B-AC0F-0403621D9C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0B62C6-5145-46AC-9CC5-53002EA0D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CF3552-604B-473D-BEC3-56BB4DC64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7E2EBC2-ED25-43E5-AEC6-E29816CC45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800786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48F281-0189-4F19-81CB-7E1649896D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F92298-603D-4333-91AF-C89B212D30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525621-7C2F-4739-8C35-CF57EBB573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BE83E7-D223-4CEA-8715-9990C41697B6}" type="datetimeFigureOut">
              <a:rPr lang="en-NZ" smtClean="0"/>
              <a:t>27/06/2022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447CDC-C82E-4B31-B38F-18B574A4C6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24304C-2295-4062-9648-11F679D0FE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44BD20-3E32-4495-B96E-3CD24FB123A9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092912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48CDCC-2174-460C-BABA-B380A287346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NZ" dirty="0">
                <a:latin typeface="Palatino Linotype" panose="02040502050505030304" pitchFamily="18" charset="0"/>
              </a:rPr>
              <a:t>Supplementary tab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32B74F2-C23B-42F4-8A4A-31F24860BF01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48002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74ACDE2A-3F3E-4BA8-9CAB-97B4E491F008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612299265"/>
              </p:ext>
            </p:extLst>
          </p:nvPr>
        </p:nvGraphicFramePr>
        <p:xfrm>
          <a:off x="876298" y="2182019"/>
          <a:ext cx="10439403" cy="3773805"/>
        </p:xfrm>
        <a:graphic>
          <a:graphicData uri="http://schemas.openxmlformats.org/drawingml/2006/table">
            <a:tbl>
              <a:tblPr/>
              <a:tblGrid>
                <a:gridCol w="1601661">
                  <a:extLst>
                    <a:ext uri="{9D8B030D-6E8A-4147-A177-3AD203B41FA5}">
                      <a16:colId xmlns:a16="http://schemas.microsoft.com/office/drawing/2014/main" val="672212015"/>
                    </a:ext>
                  </a:extLst>
                </a:gridCol>
                <a:gridCol w="514820">
                  <a:extLst>
                    <a:ext uri="{9D8B030D-6E8A-4147-A177-3AD203B41FA5}">
                      <a16:colId xmlns:a16="http://schemas.microsoft.com/office/drawing/2014/main" val="560743389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4238204461"/>
                    </a:ext>
                  </a:extLst>
                </a:gridCol>
                <a:gridCol w="915235">
                  <a:extLst>
                    <a:ext uri="{9D8B030D-6E8A-4147-A177-3AD203B41FA5}">
                      <a16:colId xmlns:a16="http://schemas.microsoft.com/office/drawing/2014/main" val="25005776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3474574759"/>
                    </a:ext>
                  </a:extLst>
                </a:gridCol>
                <a:gridCol w="695960">
                  <a:extLst>
                    <a:ext uri="{9D8B030D-6E8A-4147-A177-3AD203B41FA5}">
                      <a16:colId xmlns:a16="http://schemas.microsoft.com/office/drawing/2014/main" val="1951803644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2356911950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4229362441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1170736963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658062063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316862275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61857257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3485196669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63756753"/>
                    </a:ext>
                  </a:extLst>
                </a:gridCol>
                <a:gridCol w="610157">
                  <a:extLst>
                    <a:ext uri="{9D8B030D-6E8A-4147-A177-3AD203B41FA5}">
                      <a16:colId xmlns:a16="http://schemas.microsoft.com/office/drawing/2014/main" val="6235826"/>
                    </a:ext>
                  </a:extLst>
                </a:gridCol>
              </a:tblGrid>
              <a:tr h="228600">
                <a:tc gridSpan="15">
                  <a:txBody>
                    <a:bodyPr/>
                    <a:lstStyle/>
                    <a:p>
                      <a:pPr algn="ct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Abdomen 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3191406"/>
                  </a:ext>
                </a:extLst>
              </a:tr>
              <a:tr h="238125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W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hite bloo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ir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eng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</a:t>
                      </a:r>
                      <a:r>
                        <a:rPr lang="en-NZ" sz="11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 concentrations (µM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P concentrations (ng/m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7584967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cell cou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of stay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181564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626672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W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069891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hite blood cell cou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8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0688169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P mg/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58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859334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137063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irs scor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47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108186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6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5771406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ength of stay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0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21943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5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2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65261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</a:t>
                      </a:r>
                      <a:r>
                        <a:rPr lang="en-NZ" sz="11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 concentrations (µM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4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91582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182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41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4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499327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6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36933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9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7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4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75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450000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59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11341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5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752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0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053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9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609090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7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629867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0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47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50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384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475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8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8913716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P concentrations (ng/ml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526531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35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562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7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0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2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57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82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99008757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71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268705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4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39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32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17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9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54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8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16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2211830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04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614032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51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99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91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052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9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1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97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527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91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1878671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8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31537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51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60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49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560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65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8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98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9156053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C7890BD-7438-440E-8242-EFBEDAAC45A1}"/>
              </a:ext>
            </a:extLst>
          </p:cNvPr>
          <p:cNvSpPr txBox="1"/>
          <p:nvPr/>
        </p:nvSpPr>
        <p:spPr>
          <a:xfrm>
            <a:off x="713638" y="1408841"/>
            <a:ext cx="109576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Table S1 (a).Spearman's rank correlation coefficient (Spearman's rho) of H</a:t>
            </a:r>
            <a:r>
              <a:rPr lang="en-US" sz="1200" baseline="-25000" dirty="0">
                <a:latin typeface="Palatino Linotype" panose="02040502050505030304" pitchFamily="18" charset="0"/>
              </a:rPr>
              <a:t>2</a:t>
            </a:r>
            <a:r>
              <a:rPr lang="en-US" sz="1200" dirty="0">
                <a:latin typeface="Palatino Linotype" panose="02040502050505030304" pitchFamily="18" charset="0"/>
              </a:rPr>
              <a:t>S and SP concentrations with clinical severity parameters, total white cell count and </a:t>
            </a:r>
          </a:p>
          <a:p>
            <a:r>
              <a:rPr lang="en-US" sz="1200" dirty="0">
                <a:latin typeface="Palatino Linotype" panose="02040502050505030304" pitchFamily="18" charset="0"/>
              </a:rPr>
              <a:t>CRP.(n=16)</a:t>
            </a:r>
            <a:endParaRPr lang="en-NZ" sz="1200" dirty="0">
              <a:latin typeface="Palatino Linotype" panose="0204050205050503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CE3815-B291-4AF4-A7DA-B53A25BB456D}"/>
              </a:ext>
            </a:extLst>
          </p:cNvPr>
          <p:cNvSpPr txBox="1"/>
          <p:nvPr/>
        </p:nvSpPr>
        <p:spPr>
          <a:xfrm>
            <a:off x="1032049" y="6117185"/>
            <a:ext cx="3715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>
                <a:latin typeface="Palatino Linotype" panose="02040502050505030304" pitchFamily="18" charset="0"/>
              </a:rPr>
              <a:t>Significant p (p&lt;0.05) values are represented in bold</a:t>
            </a:r>
          </a:p>
        </p:txBody>
      </p:sp>
    </p:spTree>
    <p:extLst>
      <p:ext uri="{BB962C8B-B14F-4D97-AF65-F5344CB8AC3E}">
        <p14:creationId xmlns:p14="http://schemas.microsoft.com/office/powerpoint/2010/main" val="26959508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AD1AFB55-16C7-4632-85A6-E205854F31F1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699276914"/>
              </p:ext>
            </p:extLst>
          </p:nvPr>
        </p:nvGraphicFramePr>
        <p:xfrm>
          <a:off x="876296" y="2185494"/>
          <a:ext cx="10439407" cy="3783330"/>
        </p:xfrm>
        <a:graphic>
          <a:graphicData uri="http://schemas.openxmlformats.org/drawingml/2006/table">
            <a:tbl>
              <a:tblPr/>
              <a:tblGrid>
                <a:gridCol w="1548161">
                  <a:extLst>
                    <a:ext uri="{9D8B030D-6E8A-4147-A177-3AD203B41FA5}">
                      <a16:colId xmlns:a16="http://schemas.microsoft.com/office/drawing/2014/main" val="2727092078"/>
                    </a:ext>
                  </a:extLst>
                </a:gridCol>
                <a:gridCol w="517937">
                  <a:extLst>
                    <a:ext uri="{9D8B030D-6E8A-4147-A177-3AD203B41FA5}">
                      <a16:colId xmlns:a16="http://schemas.microsoft.com/office/drawing/2014/main" val="1810948771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1418493034"/>
                    </a:ext>
                  </a:extLst>
                </a:gridCol>
                <a:gridCol w="920775">
                  <a:extLst>
                    <a:ext uri="{9D8B030D-6E8A-4147-A177-3AD203B41FA5}">
                      <a16:colId xmlns:a16="http://schemas.microsoft.com/office/drawing/2014/main" val="4019322054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310412655"/>
                    </a:ext>
                  </a:extLst>
                </a:gridCol>
                <a:gridCol w="700173">
                  <a:extLst>
                    <a:ext uri="{9D8B030D-6E8A-4147-A177-3AD203B41FA5}">
                      <a16:colId xmlns:a16="http://schemas.microsoft.com/office/drawing/2014/main" val="807269801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3297146669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3272099003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2381043545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3910605344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3539600497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954496029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2132457764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1138327091"/>
                    </a:ext>
                  </a:extLst>
                </a:gridCol>
                <a:gridCol w="613851">
                  <a:extLst>
                    <a:ext uri="{9D8B030D-6E8A-4147-A177-3AD203B41FA5}">
                      <a16:colId xmlns:a16="http://schemas.microsoft.com/office/drawing/2014/main" val="2521231981"/>
                    </a:ext>
                  </a:extLst>
                </a:gridCol>
              </a:tblGrid>
              <a:tr h="228600">
                <a:tc gridSpan="15">
                  <a:txBody>
                    <a:bodyPr/>
                    <a:lstStyle/>
                    <a:p>
                      <a:pPr algn="ctr" fontAlgn="b"/>
                      <a:r>
                        <a:rPr lang="en-NZ" sz="11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Urinary Trac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4313323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1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W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hite blood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ir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ength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</a:t>
                      </a:r>
                      <a:r>
                        <a:rPr lang="en-NZ" sz="11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 concentrations (µM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P concentrations (ng/ml)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10967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 cell cou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mg/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core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of stay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096306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0525444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EWS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4758161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White blood cell count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2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3074369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CRP mg/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9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27298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4948455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irs score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82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976211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2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5669382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Length of stay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96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260379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3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20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2347541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H</a:t>
                      </a:r>
                      <a:r>
                        <a:rPr lang="en-NZ" sz="11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2</a:t>
                      </a:r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 concentrations (µM)</a:t>
                      </a:r>
                      <a:endParaRPr lang="en-N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36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622770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7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342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79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2054278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0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82815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3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36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6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57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9925285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49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26455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8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16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2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435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70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089116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8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2780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26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5203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50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514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828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74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16102964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SP concentrations (ng/ml)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0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199276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6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20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6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08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9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7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5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4786860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19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69566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08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190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73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13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4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4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10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255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23632523"/>
                  </a:ext>
                </a:extLst>
              </a:tr>
              <a:tr h="209550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70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27516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124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964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18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316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86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7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6972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4296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49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3511201"/>
                  </a:ext>
                </a:extLst>
              </a:tr>
              <a:tr h="219075"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Day 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25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206680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380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106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882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43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243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048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74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-0.273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51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0.934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NZ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515362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76FA468-979E-4959-86A4-F1DCF3D155C1}"/>
              </a:ext>
            </a:extLst>
          </p:cNvPr>
          <p:cNvSpPr txBox="1"/>
          <p:nvPr/>
        </p:nvSpPr>
        <p:spPr>
          <a:xfrm>
            <a:off x="876295" y="1405545"/>
            <a:ext cx="1043940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Palatino Linotype" panose="02040502050505030304" pitchFamily="18" charset="0"/>
              </a:rPr>
              <a:t>Table S1 (b). Spearman's rank correlation coefficient (Spearman's rho) of H</a:t>
            </a:r>
            <a:r>
              <a:rPr lang="en-US" sz="1200" baseline="-25000" dirty="0">
                <a:latin typeface="Palatino Linotype" panose="02040502050505030304" pitchFamily="18" charset="0"/>
              </a:rPr>
              <a:t>2</a:t>
            </a:r>
            <a:r>
              <a:rPr lang="en-US" sz="1200" dirty="0">
                <a:latin typeface="Palatino Linotype" panose="02040502050505030304" pitchFamily="18" charset="0"/>
              </a:rPr>
              <a:t>S and SP concentrations with clinical severity parameters, total white cell count and CRP.(n=34)</a:t>
            </a:r>
            <a:endParaRPr lang="en-NZ" sz="1200" dirty="0">
              <a:latin typeface="Palatino Linotype" panose="0204050205050503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AAA7853-09F6-4B93-AE71-A3F4F17AB453}"/>
              </a:ext>
            </a:extLst>
          </p:cNvPr>
          <p:cNvSpPr txBox="1"/>
          <p:nvPr/>
        </p:nvSpPr>
        <p:spPr>
          <a:xfrm>
            <a:off x="876296" y="6059520"/>
            <a:ext cx="37151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sz="1200" dirty="0">
                <a:latin typeface="Palatino Linotype" panose="02040502050505030304" pitchFamily="18" charset="0"/>
              </a:rPr>
              <a:t>Significant p (p&lt;0.05) values are represented in bold</a:t>
            </a:r>
          </a:p>
        </p:txBody>
      </p:sp>
    </p:spTree>
    <p:extLst>
      <p:ext uri="{BB962C8B-B14F-4D97-AF65-F5344CB8AC3E}">
        <p14:creationId xmlns:p14="http://schemas.microsoft.com/office/powerpoint/2010/main" val="919904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56</TotalTime>
  <Words>764</Words>
  <Application>Microsoft Office PowerPoint</Application>
  <PresentationFormat>Widescreen</PresentationFormat>
  <Paragraphs>47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Supplementary tabl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meet</dc:creator>
  <cp:lastModifiedBy>Sumeet</cp:lastModifiedBy>
  <cp:revision>20</cp:revision>
  <cp:lastPrinted>2022-06-21T23:28:57Z</cp:lastPrinted>
  <dcterms:created xsi:type="dcterms:W3CDTF">2022-06-21T23:28:54Z</dcterms:created>
  <dcterms:modified xsi:type="dcterms:W3CDTF">2022-06-27T08:10:09Z</dcterms:modified>
</cp:coreProperties>
</file>